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iall Waterbright" initials="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52" autoAdjust="0"/>
    <p:restoredTop sz="94524" autoAdjust="0"/>
  </p:normalViewPr>
  <p:slideViewPr>
    <p:cSldViewPr snapToGrid="0">
      <p:cViewPr>
        <p:scale>
          <a:sx n="70" d="100"/>
          <a:sy n="70" d="100"/>
        </p:scale>
        <p:origin x="-2946" y="-372"/>
      </p:cViewPr>
      <p:guideLst>
        <p:guide orient="horz" pos="2880"/>
        <p:guide pos="37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>
              <a:defRPr sz="1200"/>
            </a:lvl1pPr>
          </a:lstStyle>
          <a:p>
            <a:fld id="{CA27994D-EA07-4540-B8FB-E1340A7146B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7" rIns="91435" bIns="45717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16463"/>
            <a:ext cx="5440363" cy="4468812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>
              <a:defRPr sz="1200"/>
            </a:lvl1pPr>
          </a:lstStyle>
          <a:p>
            <a:fld id="{D4FE59A2-6B6F-470E-9075-FD9A46E9EC4C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2896356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196752" y="4788024"/>
          <a:ext cx="5184582" cy="609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98814"/>
                <a:gridCol w="398814"/>
                <a:gridCol w="398814"/>
                <a:gridCol w="398814"/>
                <a:gridCol w="398814"/>
                <a:gridCol w="398814"/>
                <a:gridCol w="398814"/>
                <a:gridCol w="398814"/>
                <a:gridCol w="398814"/>
                <a:gridCol w="398814"/>
                <a:gridCol w="398814"/>
                <a:gridCol w="398814"/>
                <a:gridCol w="398814"/>
              </a:tblGrid>
              <a:tr h="252028"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My</a:t>
                      </a:r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D88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My</a:t>
                      </a:r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D88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252A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253A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</a:t>
                      </a:r>
                    </a:p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34A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252A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253A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51 234A</a:t>
                      </a:r>
                      <a:endParaRPr lang="en-AU" sz="7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252028"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latin typeface="Arial" pitchFamily="34" charset="0"/>
                          <a:cs typeface="Arial" pitchFamily="34" charset="0"/>
                        </a:rPr>
                        <a:t>RT66</a:t>
                      </a:r>
                      <a:endParaRPr lang="en-AU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VT</a:t>
                      </a:r>
                      <a:endParaRPr lang="en-AU" sz="70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latin typeface="Arial" pitchFamily="34" charset="0"/>
                          <a:cs typeface="Arial" pitchFamily="34" charset="0"/>
                        </a:rPr>
                        <a:t>RT66</a:t>
                      </a:r>
                      <a:endParaRPr lang="en-AU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VT</a:t>
                      </a:r>
                      <a:endParaRPr lang="en-AU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latin typeface="Arial" pitchFamily="34" charset="0"/>
                          <a:cs typeface="Arial" pitchFamily="34" charset="0"/>
                        </a:rPr>
                        <a:t>RT66</a:t>
                      </a:r>
                      <a:endParaRPr lang="en-AU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latin typeface="Arial" pitchFamily="34" charset="0"/>
                          <a:cs typeface="Arial" pitchFamily="34" charset="0"/>
                        </a:rPr>
                        <a:t>RT66</a:t>
                      </a:r>
                      <a:endParaRPr lang="en-AU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AU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66252A</a:t>
                      </a:r>
                      <a:endParaRPr lang="en-AU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66253A</a:t>
                      </a:r>
                      <a:endParaRPr lang="en-AU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66234A</a:t>
                      </a:r>
                      <a:endParaRPr lang="en-AU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66252A</a:t>
                      </a:r>
                      <a:endParaRPr lang="en-AU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66253A</a:t>
                      </a:r>
                      <a:endParaRPr lang="en-AU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AU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T66 234A</a:t>
                      </a:r>
                      <a:endParaRPr lang="en-AU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764704" y="4788024"/>
            <a:ext cx="432048" cy="2160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Bait</a:t>
            </a:r>
            <a:endParaRPr lang="en-AU" sz="9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764704" y="5076056"/>
            <a:ext cx="432048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rey</a:t>
            </a:r>
            <a:endParaRPr lang="en-AU" sz="9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 rot="16200000">
            <a:off x="-243408" y="3275856"/>
            <a:ext cx="1728192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2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uciferase</a:t>
            </a:r>
            <a:r>
              <a:rPr lang="en-AU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signal  (log) </a:t>
            </a:r>
            <a:endParaRPr lang="en-AU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620688" y="5508104"/>
            <a:ext cx="5688632" cy="21602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b="1" smtClean="0">
                <a:latin typeface="Arial" pitchFamily="34" charset="0"/>
                <a:cs typeface="Arial" pitchFamily="34" charset="0"/>
              </a:rPr>
              <a:t>S7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.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Effect of the RT mutations W252A, T253A and L234A on RT heterodimer formation. </a:t>
            </a:r>
            <a:endParaRPr lang="en-US" sz="1200" noProof="0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4704" y="2123728"/>
            <a:ext cx="5832649" cy="26849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0" name="Straight Connector 9"/>
          <p:cNvCxnSpPr/>
          <p:nvPr/>
        </p:nvCxnSpPr>
        <p:spPr>
          <a:xfrm>
            <a:off x="1412776" y="2483768"/>
            <a:ext cx="0" cy="360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412776" y="2483768"/>
            <a:ext cx="35283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941168" y="2483768"/>
            <a:ext cx="0" cy="5760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1340768" y="2339752"/>
            <a:ext cx="0" cy="50405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1340768" y="2339752"/>
            <a:ext cx="475252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6093296" y="2339752"/>
            <a:ext cx="0" cy="7920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/>
          <p:cNvSpPr/>
          <p:nvPr/>
        </p:nvSpPr>
        <p:spPr>
          <a:xfrm>
            <a:off x="3645024" y="2195736"/>
            <a:ext cx="360040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dirty="0" smtClean="0">
                <a:solidFill>
                  <a:schemeClr val="tx1"/>
                </a:solidFill>
              </a:rPr>
              <a:t>*</a:t>
            </a:r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2852936" y="2411760"/>
            <a:ext cx="360040" cy="1440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dirty="0" smtClean="0">
                <a:solidFill>
                  <a:schemeClr val="tx1"/>
                </a:solidFill>
              </a:rPr>
              <a:t>*</a:t>
            </a:r>
            <a:endParaRPr lang="en-AU" dirty="0">
              <a:solidFill>
                <a:schemeClr val="tx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2</TotalTime>
  <Words>57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Queensland Institute of Medical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ngsheL</dc:creator>
  <cp:lastModifiedBy>dongshel</cp:lastModifiedBy>
  <cp:revision>519</cp:revision>
  <dcterms:created xsi:type="dcterms:W3CDTF">2014-03-06T01:01:54Z</dcterms:created>
  <dcterms:modified xsi:type="dcterms:W3CDTF">2015-11-04T23:32:40Z</dcterms:modified>
</cp:coreProperties>
</file>